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17C1B-FACD-4092-822A-FF61244C80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B5BF6-646A-4E3F-8719-95712DC7DE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C85C7-2062-4667-867D-E5465217B6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9493C-64E5-4EDF-85B7-30FC69FBF2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588C1-F809-4F2F-91A2-BD2D1F72E1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7639E-EB4B-4D88-8B0A-D1B46950F6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6FBAD-0C1E-4ACA-87B3-7353E766D5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941F6-447C-4801-A14E-497205AC08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53276-AEF2-41F4-85A8-1EBDFDE42D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00D2E-E791-49B5-8E14-0574375F66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E64D1-8ECE-4C13-837A-DE5813422B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2382D-D8D4-4613-9AEE-5B6A50B61E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0D3729-C736-4B6F-9504-A7F3D320256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33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6553080" cy="512460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685800" y="1609560"/>
            <a:ext cx="6553080" cy="508176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685800" y="1609560"/>
            <a:ext cx="6629400" cy="5116680"/>
          </a:xfrm>
          <a:prstGeom prst="rect">
            <a:avLst/>
          </a:prstGeom>
          <a:ln w="0">
            <a:noFill/>
          </a:ln>
        </p:spPr>
      </p:pic>
      <p:sp>
        <p:nvSpPr>
          <p:cNvPr id="80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685800" y="1590840"/>
            <a:ext cx="6629400" cy="5121000"/>
          </a:xfrm>
          <a:prstGeom prst="rect">
            <a:avLst/>
          </a:prstGeom>
          <a:ln w="0">
            <a:noFill/>
          </a:ln>
        </p:spPr>
      </p:pic>
      <p:sp>
        <p:nvSpPr>
          <p:cNvPr id="82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8610480" y="6553080"/>
            <a:ext cx="152640" cy="152640"/>
          </a:xfrm>
          <a:prstGeom prst="ellipse">
            <a:avLst/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685800" y="1419120"/>
            <a:ext cx="3695760" cy="353376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2"/>
          <a:stretch/>
        </p:blipFill>
        <p:spPr>
          <a:xfrm>
            <a:off x="4419720" y="3886200"/>
            <a:ext cx="4676760" cy="263844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 – 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here resulting in a false negative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flipH="1">
            <a:off x="3657240" y="1905120"/>
            <a:ext cx="1981080" cy="9144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5791320" y="1600200"/>
            <a:ext cx="31240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Deceiving “full” layer of epidermis on sec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3962520" y="5410080"/>
            <a:ext cx="1752480" cy="5335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371600" y="5289480"/>
            <a:ext cx="312408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Tumor has rolled to the top of the section, resulting in a false negativ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666720" y="1704960"/>
            <a:ext cx="7943760" cy="41623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 flipV="1">
            <a:off x="3124080" y="2819160"/>
            <a:ext cx="4343400" cy="152388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343400" y="2743200"/>
            <a:ext cx="2666880" cy="190512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352680" y="3276720"/>
            <a:ext cx="4724640" cy="60948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5028840" y="2514600"/>
            <a:ext cx="685800" cy="251460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An exaggerated mode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809880" y="2895480"/>
            <a:ext cx="3810240" cy="144792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876920" y="2590920"/>
            <a:ext cx="1371600" cy="236196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3200400" y="3352320"/>
            <a:ext cx="4952880" cy="30492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3885840" y="2590920"/>
            <a:ext cx="2590920" cy="2286000"/>
          </a:xfrm>
          <a:prstGeom prst="line">
            <a:avLst/>
          </a:prstGeom>
          <a:ln w="57240">
            <a:solidFill>
              <a:srgbClr val="ffffff"/>
            </a:solidFill>
            <a:miter/>
            <a:headEnd len="med" type="diamond" w="med"/>
            <a:tailEnd len="med" type="diamond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33520" y="649116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Normally, a stage would not be cut into thin slivers…but if it was, it may look like this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666720" y="1571760"/>
            <a:ext cx="7810560" cy="49813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4495680" y="4038480"/>
            <a:ext cx="3124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Dermi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495680" y="2666880"/>
            <a:ext cx="3124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Epithelium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495680" y="5410080"/>
            <a:ext cx="3124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Fat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533520" y="1371600"/>
            <a:ext cx="3695760" cy="387684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2"/>
          <a:stretch/>
        </p:blipFill>
        <p:spPr>
          <a:xfrm>
            <a:off x="5105520" y="4114800"/>
            <a:ext cx="3638520" cy="249408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 flipH="1">
            <a:off x="2590920" y="2286000"/>
            <a:ext cx="2666880" cy="152388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5257800" y="2286000"/>
            <a:ext cx="1447920" cy="289548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410080" y="2057400"/>
            <a:ext cx="3124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Tumor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685800" y="1590840"/>
            <a:ext cx="6553080" cy="507024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33520" y="649116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This block may, in error, fall to the side when processing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6629400" cy="507528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695160" y="1600200"/>
            <a:ext cx="6620040" cy="510840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6629400" cy="512604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6629400" cy="512748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Thin Section Collaps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09T15:32:57Z</dcterms:created>
  <dc:creator>je</dc:creator>
  <dc:description/>
  <dc:language>en-US</dc:language>
  <cp:lastModifiedBy>je</cp:lastModifiedBy>
  <dcterms:modified xsi:type="dcterms:W3CDTF">2006-01-09T18:26:26Z</dcterms:modified>
  <cp:revision>3</cp:revision>
  <dc:subject/>
  <dc:title>#4: Thin Section Collapse</dc:title>
</cp:coreProperties>
</file>